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30" autoAdjust="0"/>
    <p:restoredTop sz="94660"/>
  </p:normalViewPr>
  <p:slideViewPr>
    <p:cSldViewPr snapToGrid="0">
      <p:cViewPr>
        <p:scale>
          <a:sx n="68" d="100"/>
          <a:sy n="68" d="100"/>
        </p:scale>
        <p:origin x="888" y="6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8CA4392-5E73-0108-CBBA-28691F1D59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0D831818-D66A-18DB-2017-A935F42A5C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945DBFD-F2FF-7765-D9DC-4D13E0376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7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3ACB39D-BD0B-B377-D862-7F76BD894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01EEF2C-F670-3E35-874B-7A6553439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45879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399512B-993D-96DA-AC3E-AAB7861E04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BD6B8C9-1712-ED3E-73BA-1670E9A317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6A1C69F-B153-4BDA-6A9F-D6B8C78A0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7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7B9D6BE-1C66-A9CD-183A-8FFB74192D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0348AB4-4AB1-23FD-AE9F-A4C54A7EC0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6540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8F1C2DFD-FDDB-EDA9-D82E-DFE1DCCED7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E70710D-9E2C-B5B9-4701-DFBF9615A4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DB6BC3F-4028-BC1A-E8ED-D0E7BA723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7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B975C6B-EB7F-F388-2D1E-22B65A833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A3504A6-B28E-9494-9EE8-4124106C2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5423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6983DC9-75BD-8969-675D-03917E38D7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01FAE08-B4BE-7188-9EF3-931CC5F9AE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5656958-63CE-07EA-BD1D-DCC8256E8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7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1E7EC13-1DAD-28E2-B8E6-85BF6C755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9791C74-5785-8DBF-4BFE-4D689906C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18846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C954263-6C6D-09E0-104C-260D25D3DE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9463E93-22D9-ED0C-168D-87EAE31EB7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4D53D07-A027-EFAF-135F-11DE7E2E1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7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921B540-D5BD-5142-05A3-4753F291F7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768CAEA-DB12-BCA1-3FEB-8BAD219D0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9115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5FD5BF1-DD48-BCFC-C990-E5DE502A74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AB54EEE-3B55-ABE1-DC2C-B1B8DD3201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0B7CFFD-CAFC-B168-7BFA-F9531324AA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6955CEB-8849-E355-8109-ACD2A4B25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7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55B132F-0F3A-8991-19AB-36271FC56A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66419C9-7C32-2130-E201-373A83BAD0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0657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E980DEA-689F-B910-8678-673A468EB3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C7F72B2-F1D6-955C-8F76-C75A09C74D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F25F160-D135-6B71-4151-5D85821BE1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C90321E-F145-4921-C287-FE635C7E86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0311CBB5-9DA1-530E-680D-D68DF21D67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2AE2CCF7-0C74-9CCD-CD7D-CE9E29E0F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7/07/2023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DE92749C-EC66-5F54-69FD-19A18A2BB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AAC9F7C4-C008-5AB0-03D1-301F3CD14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1415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A4F8CB4-AACB-DCBE-07E9-FBA9A2A94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54F15A6-4026-154B-C252-0FF94CA07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7/07/2023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D216B02-FBEB-D41A-28DA-750E2B6ADF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47ABF464-DCBD-ACE2-D66B-B447DE8FC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6795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FBC671B-7586-C677-B853-2C705E63A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7/07/2023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401ED5C2-142F-82C4-7FF5-41F16DAAB2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23E5E6F4-AF49-C23E-14C2-699C56515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18037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9259816-12EA-74F9-6BA5-4FD35CB44E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5C1C8ED-6485-4D35-69D6-17E578A2A3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128AE38-51BA-F1D6-B2F5-1F38A24517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C29B3D1-B531-81EF-AE34-BC61D910DC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7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715909C-B024-CDA0-C746-E68FAEDEA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F7E54C9-A667-1011-0551-28B57432F7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4238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4ABADBE-91EB-E67C-44C0-062D0A7F5B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BFAD65BE-9342-E1B6-7EEC-8F5C3107245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D29A3AF-E859-18E6-6E6B-B611064D49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7628F86-C761-29AA-ED8E-1974A91764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485C-36A0-4164-A4C8-28F5001E2DB2}" type="datetimeFigureOut">
              <a:rPr lang="es-ES" smtClean="0"/>
              <a:t>17/07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35DA35A-2D9C-32BF-AC0B-A29D49B043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3D0A14D-A3A9-2456-DCDF-CC7BA7FBB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20026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FDD870D1-4E17-32B3-0525-D3D052031F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3431573-D3DA-3DD4-6756-5B6ACD9893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5D1E7DB-2951-B127-367A-97FEDC0FAD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28485C-36A0-4164-A4C8-28F5001E2DB2}" type="datetimeFigureOut">
              <a:rPr lang="es-ES" smtClean="0"/>
              <a:t>17/07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E9843E6-E161-EE41-6982-F48050A3DF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F3A41A4-FBD4-91E9-9BB0-F4579A0FCC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779D77-5D36-4A50-AA10-916989D438A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67460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249F3737-2ECA-678D-A59E-494C5B48DC5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93" t="28864" r="17576" b="14799"/>
          <a:stretch/>
        </p:blipFill>
        <p:spPr>
          <a:xfrm>
            <a:off x="2771775" y="1114425"/>
            <a:ext cx="4543425" cy="3819523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8" name="Grupo 7">
            <a:extLst>
              <a:ext uri="{FF2B5EF4-FFF2-40B4-BE49-F238E27FC236}">
                <a16:creationId xmlns:a16="http://schemas.microsoft.com/office/drawing/2014/main" id="{6ECEC6D2-B89B-EC32-D2E5-16233731C6B3}"/>
              </a:ext>
            </a:extLst>
          </p:cNvPr>
          <p:cNvGrpSpPr/>
          <p:nvPr/>
        </p:nvGrpSpPr>
        <p:grpSpPr>
          <a:xfrm>
            <a:off x="1447635" y="2236284"/>
            <a:ext cx="1520873" cy="2289983"/>
            <a:chOff x="4546510" y="3219994"/>
            <a:chExt cx="724737" cy="1090153"/>
          </a:xfrm>
        </p:grpSpPr>
        <p:grpSp>
          <p:nvGrpSpPr>
            <p:cNvPr id="9" name="Grupo 8">
              <a:extLst>
                <a:ext uri="{FF2B5EF4-FFF2-40B4-BE49-F238E27FC236}">
                  <a16:creationId xmlns:a16="http://schemas.microsoft.com/office/drawing/2014/main" id="{FBB40FF9-F291-150D-61CF-821F5A252FE8}"/>
                </a:ext>
              </a:extLst>
            </p:cNvPr>
            <p:cNvGrpSpPr/>
            <p:nvPr/>
          </p:nvGrpSpPr>
          <p:grpSpPr>
            <a:xfrm>
              <a:off x="4999646" y="3310666"/>
              <a:ext cx="271601" cy="915415"/>
              <a:chOff x="4999646" y="3310666"/>
              <a:chExt cx="271601" cy="915415"/>
            </a:xfrm>
          </p:grpSpPr>
          <p:cxnSp>
            <p:nvCxnSpPr>
              <p:cNvPr id="19" name="Conector recto 18">
                <a:extLst>
                  <a:ext uri="{FF2B5EF4-FFF2-40B4-BE49-F238E27FC236}">
                    <a16:creationId xmlns:a16="http://schemas.microsoft.com/office/drawing/2014/main" id="{6832DE56-29C6-7D0D-9027-606FBE897E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1066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ector recto 19">
                <a:extLst>
                  <a:ext uri="{FF2B5EF4-FFF2-40B4-BE49-F238E27FC236}">
                    <a16:creationId xmlns:a16="http://schemas.microsoft.com/office/drawing/2014/main" id="{4FC2D830-27B3-DC62-91D0-9648EFE398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2143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ector recto 20">
                <a:extLst>
                  <a:ext uri="{FF2B5EF4-FFF2-40B4-BE49-F238E27FC236}">
                    <a16:creationId xmlns:a16="http://schemas.microsoft.com/office/drawing/2014/main" id="{CB9017B7-481F-5B33-8B78-F133DF6C188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ector recto 21">
                <a:extLst>
                  <a:ext uri="{FF2B5EF4-FFF2-40B4-BE49-F238E27FC236}">
                    <a16:creationId xmlns:a16="http://schemas.microsoft.com/office/drawing/2014/main" id="{19A39EC1-E3D3-F676-75C7-32340632D8C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80900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4" name="Conector recto 23">
                <a:extLst>
                  <a:ext uri="{FF2B5EF4-FFF2-40B4-BE49-F238E27FC236}">
                    <a16:creationId xmlns:a16="http://schemas.microsoft.com/office/drawing/2014/main" id="{665D59D2-5E30-C130-8B3D-560E6D0A07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ector recto 25">
                <a:extLst>
                  <a:ext uri="{FF2B5EF4-FFF2-40B4-BE49-F238E27FC236}">
                    <a16:creationId xmlns:a16="http://schemas.microsoft.com/office/drawing/2014/main" id="{2DBAE913-8726-4919-0D4F-164BAC8D7D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31389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Conector recto 26">
                <a:extLst>
                  <a:ext uri="{FF2B5EF4-FFF2-40B4-BE49-F238E27FC236}">
                    <a16:creationId xmlns:a16="http://schemas.microsoft.com/office/drawing/2014/main" id="{73122490-A3EF-1CCF-57A2-73126CB81FB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6" y="4226081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16ADC64E-B653-5748-8F85-99419827A74F}"/>
                </a:ext>
              </a:extLst>
            </p:cNvPr>
            <p:cNvSpPr txBox="1"/>
            <p:nvPr/>
          </p:nvSpPr>
          <p:spPr>
            <a:xfrm>
              <a:off x="4546510" y="3219994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82kDa</a:t>
              </a:r>
            </a:p>
          </p:txBody>
        </p:sp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7E5B1FD5-4AF1-8B64-E37E-814844183295}"/>
                </a:ext>
              </a:extLst>
            </p:cNvPr>
            <p:cNvSpPr txBox="1"/>
            <p:nvPr/>
          </p:nvSpPr>
          <p:spPr>
            <a:xfrm>
              <a:off x="4546510" y="3419650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16kDa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03FF876E-8C70-EDE0-047E-831FE8D2F68F}"/>
                </a:ext>
              </a:extLst>
            </p:cNvPr>
            <p:cNvSpPr txBox="1"/>
            <p:nvPr/>
          </p:nvSpPr>
          <p:spPr>
            <a:xfrm>
              <a:off x="4594771" y="3559114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82kDa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691369C1-1220-FF9C-CECC-883C8C62DF9B}"/>
                </a:ext>
              </a:extLst>
            </p:cNvPr>
            <p:cNvSpPr txBox="1"/>
            <p:nvPr/>
          </p:nvSpPr>
          <p:spPr>
            <a:xfrm>
              <a:off x="4595360" y="371931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64kDa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4B4074FA-5243-54A2-EC82-CC6810F1078D}"/>
                </a:ext>
              </a:extLst>
            </p:cNvPr>
            <p:cNvSpPr txBox="1"/>
            <p:nvPr/>
          </p:nvSpPr>
          <p:spPr>
            <a:xfrm>
              <a:off x="4594769" y="3853888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49kDa</a:t>
              </a: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DAD07FD7-BCCB-78CA-A0D3-57B576949E63}"/>
                </a:ext>
              </a:extLst>
            </p:cNvPr>
            <p:cNvSpPr txBox="1"/>
            <p:nvPr/>
          </p:nvSpPr>
          <p:spPr>
            <a:xfrm>
              <a:off x="4595360" y="4013871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37kDa</a:t>
              </a: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004BF03E-1D72-3441-66DB-949991E03FD6}"/>
                </a:ext>
              </a:extLst>
            </p:cNvPr>
            <p:cNvSpPr txBox="1"/>
            <p:nvPr/>
          </p:nvSpPr>
          <p:spPr>
            <a:xfrm>
              <a:off x="4592261" y="4119484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26kDa</a:t>
              </a:r>
            </a:p>
          </p:txBody>
        </p:sp>
      </p:grpSp>
      <p:sp>
        <p:nvSpPr>
          <p:cNvPr id="29" name="CuadroTexto 28">
            <a:extLst>
              <a:ext uri="{FF2B5EF4-FFF2-40B4-BE49-F238E27FC236}">
                <a16:creationId xmlns:a16="http://schemas.microsoft.com/office/drawing/2014/main" id="{2135E244-1F3B-7BF0-3F61-E9745CC66162}"/>
              </a:ext>
            </a:extLst>
          </p:cNvPr>
          <p:cNvSpPr txBox="1"/>
          <p:nvPr/>
        </p:nvSpPr>
        <p:spPr>
          <a:xfrm>
            <a:off x="7447069" y="2226297"/>
            <a:ext cx="792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NLRP1</a:t>
            </a:r>
          </a:p>
        </p:txBody>
      </p:sp>
      <p:sp>
        <p:nvSpPr>
          <p:cNvPr id="30" name="Rectángulo 29">
            <a:extLst>
              <a:ext uri="{FF2B5EF4-FFF2-40B4-BE49-F238E27FC236}">
                <a16:creationId xmlns:a16="http://schemas.microsoft.com/office/drawing/2014/main" id="{E74161A8-0EA0-0E29-6DB3-12E4B8BA11B5}"/>
              </a:ext>
            </a:extLst>
          </p:cNvPr>
          <p:cNvSpPr/>
          <p:nvPr/>
        </p:nvSpPr>
        <p:spPr>
          <a:xfrm>
            <a:off x="3100374" y="2110263"/>
            <a:ext cx="1100151" cy="74567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84D3EA54-4A00-DE9C-7E19-0C088717B835}"/>
              </a:ext>
            </a:extLst>
          </p:cNvPr>
          <p:cNvSpPr txBox="1"/>
          <p:nvPr/>
        </p:nvSpPr>
        <p:spPr>
          <a:xfrm>
            <a:off x="2771775" y="603335"/>
            <a:ext cx="1802098" cy="4001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s-ES_tradnl" sz="2000" dirty="0" err="1">
                <a:latin typeface="Arial" charset="0"/>
                <a:ea typeface="Arial" charset="0"/>
                <a:cs typeface="Arial" charset="0"/>
              </a:rPr>
              <a:t>Hemin</a:t>
            </a:r>
            <a:r>
              <a:rPr lang="es-ES_tradnl" sz="20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s-ES_tradnl" sz="2000" dirty="0" err="1">
                <a:latin typeface="Arial" charset="0"/>
                <a:ea typeface="Arial" charset="0"/>
                <a:cs typeface="Arial" charset="0"/>
              </a:rPr>
              <a:t>hours</a:t>
            </a:r>
            <a:r>
              <a:rPr lang="es-ES_tradnl" sz="2000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935DF1CE-9C86-BAEA-FCBC-116924EE940B}"/>
              </a:ext>
            </a:extLst>
          </p:cNvPr>
          <p:cNvSpPr txBox="1"/>
          <p:nvPr/>
        </p:nvSpPr>
        <p:spPr>
          <a:xfrm>
            <a:off x="2993160" y="1097343"/>
            <a:ext cx="12073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2000" dirty="0">
                <a:latin typeface="Arial" charset="0"/>
                <a:ea typeface="Arial" charset="0"/>
                <a:cs typeface="Arial" charset="0"/>
              </a:rPr>
              <a:t> 0  24 48</a:t>
            </a:r>
          </a:p>
        </p:txBody>
      </p:sp>
      <p:cxnSp>
        <p:nvCxnSpPr>
          <p:cNvPr id="33" name="Conector recto 32">
            <a:extLst>
              <a:ext uri="{FF2B5EF4-FFF2-40B4-BE49-F238E27FC236}">
                <a16:creationId xmlns:a16="http://schemas.microsoft.com/office/drawing/2014/main" id="{6AB4F24E-2418-3177-99FE-E328E98D14F3}"/>
              </a:ext>
            </a:extLst>
          </p:cNvPr>
          <p:cNvCxnSpPr>
            <a:cxnSpLocks/>
          </p:cNvCxnSpPr>
          <p:nvPr/>
        </p:nvCxnSpPr>
        <p:spPr>
          <a:xfrm flipV="1">
            <a:off x="2933700" y="1020527"/>
            <a:ext cx="1428750" cy="8173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61262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 descr="Un conjunto de letras negras en un fondo blanco&#10;&#10;Descripción generada automáticamente con confianza media">
            <a:extLst>
              <a:ext uri="{FF2B5EF4-FFF2-40B4-BE49-F238E27FC236}">
                <a16:creationId xmlns:a16="http://schemas.microsoft.com/office/drawing/2014/main" id="{69940750-B75B-B98F-BF39-EBC60BB5F16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96" t="31603" r="24242" b="9915"/>
          <a:stretch/>
        </p:blipFill>
        <p:spPr>
          <a:xfrm>
            <a:off x="2968497" y="1229502"/>
            <a:ext cx="7125899" cy="4594829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8" name="Grupo 27">
            <a:extLst>
              <a:ext uri="{FF2B5EF4-FFF2-40B4-BE49-F238E27FC236}">
                <a16:creationId xmlns:a16="http://schemas.microsoft.com/office/drawing/2014/main" id="{FDB1CC8B-16EF-CD3C-70E4-D811D6D67D15}"/>
              </a:ext>
            </a:extLst>
          </p:cNvPr>
          <p:cNvGrpSpPr/>
          <p:nvPr/>
        </p:nvGrpSpPr>
        <p:grpSpPr>
          <a:xfrm>
            <a:off x="1457161" y="2207709"/>
            <a:ext cx="1511348" cy="2411995"/>
            <a:chOff x="4551049" y="3206392"/>
            <a:chExt cx="720198" cy="1149380"/>
          </a:xfrm>
        </p:grpSpPr>
        <p:grpSp>
          <p:nvGrpSpPr>
            <p:cNvPr id="18" name="Grupo 17">
              <a:extLst>
                <a:ext uri="{FF2B5EF4-FFF2-40B4-BE49-F238E27FC236}">
                  <a16:creationId xmlns:a16="http://schemas.microsoft.com/office/drawing/2014/main" id="{5C5C9A81-39F7-CA72-F4EC-6D41B05E5D5F}"/>
                </a:ext>
              </a:extLst>
            </p:cNvPr>
            <p:cNvGrpSpPr/>
            <p:nvPr/>
          </p:nvGrpSpPr>
          <p:grpSpPr>
            <a:xfrm>
              <a:off x="4999646" y="3310666"/>
              <a:ext cx="271601" cy="951689"/>
              <a:chOff x="4999646" y="3310666"/>
              <a:chExt cx="271601" cy="951689"/>
            </a:xfrm>
          </p:grpSpPr>
          <p:cxnSp>
            <p:nvCxnSpPr>
              <p:cNvPr id="9" name="Conector recto 8">
                <a:extLst>
                  <a:ext uri="{FF2B5EF4-FFF2-40B4-BE49-F238E27FC236}">
                    <a16:creationId xmlns:a16="http://schemas.microsoft.com/office/drawing/2014/main" id="{FD90A43C-9048-A5AC-10BC-70DAB1C6AB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2" y="3310666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Conector recto 9">
                <a:extLst>
                  <a:ext uri="{FF2B5EF4-FFF2-40B4-BE49-F238E27FC236}">
                    <a16:creationId xmlns:a16="http://schemas.microsoft.com/office/drawing/2014/main" id="{E2503524-EB46-9E44-B4F5-8815FA176C2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521432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Conector recto 10">
                <a:extLst>
                  <a:ext uri="{FF2B5EF4-FFF2-40B4-BE49-F238E27FC236}">
                    <a16:creationId xmlns:a16="http://schemas.microsoft.com/office/drawing/2014/main" id="{B655AA13-5100-8B5C-A25A-13030A6FFB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1" y="3649513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Conector recto 11">
                <a:extLst>
                  <a:ext uri="{FF2B5EF4-FFF2-40B4-BE49-F238E27FC236}">
                    <a16:creationId xmlns:a16="http://schemas.microsoft.com/office/drawing/2014/main" id="{5EA44011-4F73-6AB3-EEE1-4824A392103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50" y="3772730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3" name="Conector recto 12">
                <a:extLst>
                  <a:ext uri="{FF2B5EF4-FFF2-40B4-BE49-F238E27FC236}">
                    <a16:creationId xmlns:a16="http://schemas.microsoft.com/office/drawing/2014/main" id="{2209C5FB-7DB9-77B4-32F2-B1EC8232AE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871628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Conector recto 13">
                <a:extLst>
                  <a:ext uri="{FF2B5EF4-FFF2-40B4-BE49-F238E27FC236}">
                    <a16:creationId xmlns:a16="http://schemas.microsoft.com/office/drawing/2014/main" id="{4083BA6D-A7E6-5C71-25AD-3EBFB39F14D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9" y="395593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ector recto 14">
                <a:extLst>
                  <a:ext uri="{FF2B5EF4-FFF2-40B4-BE49-F238E27FC236}">
                    <a16:creationId xmlns:a16="http://schemas.microsoft.com/office/drawing/2014/main" id="{1DEDB711-5509-2260-E8FA-4E01DA3178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8" y="4064560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ector recto 15">
                <a:extLst>
                  <a:ext uri="{FF2B5EF4-FFF2-40B4-BE49-F238E27FC236}">
                    <a16:creationId xmlns:a16="http://schemas.microsoft.com/office/drawing/2014/main" id="{367ECE55-9E4D-D06E-4018-7DC43C5A549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7" y="4158594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ector recto 16">
                <a:extLst>
                  <a:ext uri="{FF2B5EF4-FFF2-40B4-BE49-F238E27FC236}">
                    <a16:creationId xmlns:a16="http://schemas.microsoft.com/office/drawing/2014/main" id="{5982D8EF-9530-C77A-496A-F2CBE3639C0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99646" y="4262355"/>
                <a:ext cx="27159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C443FC09-37F5-8D7A-8089-6CB36EECACF1}"/>
                </a:ext>
              </a:extLst>
            </p:cNvPr>
            <p:cNvSpPr txBox="1"/>
            <p:nvPr/>
          </p:nvSpPr>
          <p:spPr>
            <a:xfrm>
              <a:off x="4551049" y="3206392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82kDa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E7F9538D-A22E-956C-A17F-42BD72FEECA5}"/>
                </a:ext>
              </a:extLst>
            </p:cNvPr>
            <p:cNvSpPr txBox="1"/>
            <p:nvPr/>
          </p:nvSpPr>
          <p:spPr>
            <a:xfrm>
              <a:off x="4551049" y="3419648"/>
              <a:ext cx="463060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16kDa</a:t>
              </a:r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4420C868-4868-3212-0356-297AE521C7BF}"/>
                </a:ext>
              </a:extLst>
            </p:cNvPr>
            <p:cNvSpPr txBox="1"/>
            <p:nvPr/>
          </p:nvSpPr>
          <p:spPr>
            <a:xfrm>
              <a:off x="4594771" y="3550045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82kDa</a:t>
              </a: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255136DC-D626-4224-813B-F890BBC44B4F}"/>
                </a:ext>
              </a:extLst>
            </p:cNvPr>
            <p:cNvSpPr txBox="1"/>
            <p:nvPr/>
          </p:nvSpPr>
          <p:spPr>
            <a:xfrm>
              <a:off x="4594770" y="3673342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64kDa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0E923351-7A52-BDA0-4D8D-B3AEE6F18C3D}"/>
                </a:ext>
              </a:extLst>
            </p:cNvPr>
            <p:cNvSpPr txBox="1"/>
            <p:nvPr/>
          </p:nvSpPr>
          <p:spPr>
            <a:xfrm>
              <a:off x="4594766" y="3769566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49kDa</a:t>
              </a: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5759B350-CCC1-7C61-01C7-C0E652126AD3}"/>
                </a:ext>
              </a:extLst>
            </p:cNvPr>
            <p:cNvSpPr txBox="1"/>
            <p:nvPr/>
          </p:nvSpPr>
          <p:spPr>
            <a:xfrm>
              <a:off x="4594759" y="3855209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37kDa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08DF9476-2C72-7A6E-2952-B8D75D32399F}"/>
                </a:ext>
              </a:extLst>
            </p:cNvPr>
            <p:cNvSpPr txBox="1"/>
            <p:nvPr/>
          </p:nvSpPr>
          <p:spPr>
            <a:xfrm>
              <a:off x="4594759" y="3965650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26kDa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8FEEC517-2A93-53E9-44B6-C72B3643078B}"/>
                </a:ext>
              </a:extLst>
            </p:cNvPr>
            <p:cNvSpPr txBox="1"/>
            <p:nvPr/>
          </p:nvSpPr>
          <p:spPr>
            <a:xfrm>
              <a:off x="4594752" y="4061004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9kDa</a:t>
              </a:r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97A51DB3-BDA9-43D4-B0CA-45612488D0BD}"/>
                </a:ext>
              </a:extLst>
            </p:cNvPr>
            <p:cNvSpPr txBox="1"/>
            <p:nvPr/>
          </p:nvSpPr>
          <p:spPr>
            <a:xfrm>
              <a:off x="4594752" y="4165109"/>
              <a:ext cx="401187" cy="190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_tradnl" sz="2000" dirty="0"/>
                <a:t>15kDa</a:t>
              </a:r>
            </a:p>
          </p:txBody>
        </p:sp>
      </p:grpSp>
      <p:sp>
        <p:nvSpPr>
          <p:cNvPr id="30" name="CuadroTexto 29">
            <a:extLst>
              <a:ext uri="{FF2B5EF4-FFF2-40B4-BE49-F238E27FC236}">
                <a16:creationId xmlns:a16="http://schemas.microsoft.com/office/drawing/2014/main" id="{CF2E5718-F873-7701-79BA-DC346D30C4D7}"/>
              </a:ext>
            </a:extLst>
          </p:cNvPr>
          <p:cNvSpPr txBox="1"/>
          <p:nvPr/>
        </p:nvSpPr>
        <p:spPr>
          <a:xfrm>
            <a:off x="10333144" y="3144315"/>
            <a:ext cx="677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CTB</a:t>
            </a:r>
          </a:p>
        </p:txBody>
      </p:sp>
      <p:sp>
        <p:nvSpPr>
          <p:cNvPr id="31" name="Rectángulo 30">
            <a:extLst>
              <a:ext uri="{FF2B5EF4-FFF2-40B4-BE49-F238E27FC236}">
                <a16:creationId xmlns:a16="http://schemas.microsoft.com/office/drawing/2014/main" id="{280CD9EE-D429-E89B-439C-C3EA9C3A4900}"/>
              </a:ext>
            </a:extLst>
          </p:cNvPr>
          <p:cNvSpPr/>
          <p:nvPr/>
        </p:nvSpPr>
        <p:spPr>
          <a:xfrm>
            <a:off x="4759891" y="3055341"/>
            <a:ext cx="1628384" cy="74567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6DFC5A4D-0299-F727-DCE5-22A21CBD1E63}"/>
              </a:ext>
            </a:extLst>
          </p:cNvPr>
          <p:cNvSpPr txBox="1"/>
          <p:nvPr/>
        </p:nvSpPr>
        <p:spPr>
          <a:xfrm>
            <a:off x="4633802" y="335384"/>
            <a:ext cx="1802098" cy="40011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s-ES_tradnl" sz="2000" dirty="0" err="1">
                <a:latin typeface="Arial" charset="0"/>
                <a:ea typeface="Arial" charset="0"/>
                <a:cs typeface="Arial" charset="0"/>
              </a:rPr>
              <a:t>Hemin</a:t>
            </a:r>
            <a:r>
              <a:rPr lang="es-ES_tradnl" sz="20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s-ES_tradnl" sz="2000" dirty="0" err="1">
                <a:latin typeface="Arial" charset="0"/>
                <a:ea typeface="Arial" charset="0"/>
                <a:cs typeface="Arial" charset="0"/>
              </a:rPr>
              <a:t>hours</a:t>
            </a:r>
            <a:r>
              <a:rPr lang="es-ES_tradnl" sz="2000" dirty="0">
                <a:latin typeface="Arial" charset="0"/>
                <a:ea typeface="Arial" charset="0"/>
                <a:cs typeface="Arial" charset="0"/>
              </a:rPr>
              <a:t>)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E4EFA5E8-3477-2F24-9110-7460580DF651}"/>
              </a:ext>
            </a:extLst>
          </p:cNvPr>
          <p:cNvSpPr txBox="1"/>
          <p:nvPr/>
        </p:nvSpPr>
        <p:spPr>
          <a:xfrm>
            <a:off x="4807562" y="829392"/>
            <a:ext cx="15807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2000" dirty="0">
                <a:latin typeface="Arial" charset="0"/>
                <a:ea typeface="Arial" charset="0"/>
                <a:cs typeface="Arial" charset="0"/>
              </a:rPr>
              <a:t> 0    24  48</a:t>
            </a:r>
          </a:p>
        </p:txBody>
      </p:sp>
      <p:cxnSp>
        <p:nvCxnSpPr>
          <p:cNvPr id="34" name="Conector recto 33">
            <a:extLst>
              <a:ext uri="{FF2B5EF4-FFF2-40B4-BE49-F238E27FC236}">
                <a16:creationId xmlns:a16="http://schemas.microsoft.com/office/drawing/2014/main" id="{9326A1D1-4DEE-52B7-1903-15FA92D9C514}"/>
              </a:ext>
            </a:extLst>
          </p:cNvPr>
          <p:cNvCxnSpPr>
            <a:cxnSpLocks/>
          </p:cNvCxnSpPr>
          <p:nvPr/>
        </p:nvCxnSpPr>
        <p:spPr>
          <a:xfrm flipV="1">
            <a:off x="4795727" y="752576"/>
            <a:ext cx="1428750" cy="8173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3565869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4</Words>
  <Application>Microsoft Office PowerPoint</Application>
  <PresentationFormat>Panorámica</PresentationFormat>
  <Paragraphs>22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MANUEL LOZANO GIL</dc:creator>
  <cp:lastModifiedBy>JUAN MANUEL LOZANO GIL</cp:lastModifiedBy>
  <cp:revision>1</cp:revision>
  <dcterms:created xsi:type="dcterms:W3CDTF">2023-07-17T13:35:44Z</dcterms:created>
  <dcterms:modified xsi:type="dcterms:W3CDTF">2023-07-17T13:48:10Z</dcterms:modified>
</cp:coreProperties>
</file>